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1"/>
          <p:cNvSpPr>
            <a:spLocks noGrp="1"/>
          </p:cNvSpPr>
          <p:nvPr>
            <p:ph type="sldImg"/>
          </p:nvPr>
        </p:nvSpPr>
        <p:spPr>
          <a:xfrm>
            <a:off x="1106280" y="812880"/>
            <a:ext cx="5343480" cy="400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 type="dt" idx="1"/>
          </p:nvPr>
        </p:nvSpPr>
        <p:spPr>
          <a:xfrm>
            <a:off x="4277880" y="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5"/>
          <p:cNvSpPr>
            <a:spLocks noGrp="1"/>
          </p:cNvSpPr>
          <p:nvPr>
            <p:ph type="ftr" idx="2"/>
          </p:nvPr>
        </p:nvSpPr>
        <p:spPr>
          <a:xfrm>
            <a:off x="0" y="1015668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6"/>
          <p:cNvSpPr>
            <a:spLocks noGrp="1"/>
          </p:cNvSpPr>
          <p:nvPr>
            <p:ph type="sldNum" idx="3"/>
          </p:nvPr>
        </p:nvSpPr>
        <p:spPr>
          <a:xfrm>
            <a:off x="427788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2F5EBE90-B3FF-4C5C-A21B-CF5C42AB3763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21900E3B-F34F-4830-A911-8DDE914B51D6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3320" cy="4008240"/>
          </a:xfrm>
          <a:prstGeom prst="rect">
            <a:avLst/>
          </a:prstGeom>
          <a:ln w="0">
            <a:noFill/>
          </a:ln>
        </p:spPr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3192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802872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6094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43192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802872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09480" y="272520"/>
            <a:ext cx="109713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 fontScale="92000"/>
          </a:bodyPr>
          <a:p>
            <a:pPr marL="315360" indent="0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"/>
          <p:cNvGraphicFramePr/>
          <p:nvPr/>
        </p:nvGraphicFramePr>
        <p:xfrm>
          <a:off x="2424240" y="1773360"/>
          <a:ext cx="5622840" cy="3516120"/>
        </p:xfrm>
        <a:graphic>
          <a:graphicData uri="http://schemas.openxmlformats.org/drawingml/2006/table">
            <a:tbl>
              <a:tblPr/>
              <a:tblGrid>
                <a:gridCol w="833400"/>
                <a:gridCol w="2622600"/>
                <a:gridCol w="2166840"/>
              </a:tblGrid>
              <a:tr h="25236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                            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CR PRIME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           </a:t>
                      </a: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ING PRIME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</a:tr>
              <a:tr h="40788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XA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4     ATTTTAGGTAGTTTTTGTGGTTGTA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 ATCCAACCTAAAAAATCTTCATCA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CTAAAAAATCTTCATCA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788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    GGGTTAGTAGTTGGGAGTTG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 ACTCTACTCAAATTACCAACTCTAT 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	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TGGGGTTTGG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40824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KL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    GGGGTGGTTGGTTTTGAGTT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 CCAAACCTCCCTTCTTCTAAT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GTTGGTTTTGAGTT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788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VC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    GGGGAGTAGGGGAGT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CCCCCCAACCCCAAAACCACT    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TAATTAGTTTTTTTTTTTT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40788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LX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    TGTTTTGGGTAGGGTAGATAGTTATTG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 CTAAAAACTTCCAATTCCTAAATATCAA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TAGGGTAGATAGTTATTG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824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    GTTTTGTTGGAATTGTTTTTTTAGAA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 AATCTTATCTACCTATAACCCACA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ATTATATTTTTTTTTGAATTT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40788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RDL3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    GTAGGTAGGGTTTTTTTTTAGGATATTAT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 ACTTTTTATATCTATCTTCACCCCTAC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GAAGTTAAGGAGAA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7880">
                <a:tc>
                  <a:txBody>
                    <a:bodyPr lIns="68400" rIns="684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IP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 algn="just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    ATTGGAAAATGGGTAGATGTAG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9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    AACCCCATTACAAAAACAAC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68400" rIns="6840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GGGAAGGTAG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</a:tbl>
          </a:graphicData>
        </a:graphic>
      </p:graphicFrame>
      <p:sp>
        <p:nvSpPr>
          <p:cNvPr id="46" name="Rectangle 95"/>
          <p:cNvSpPr/>
          <p:nvPr/>
        </p:nvSpPr>
        <p:spPr>
          <a:xfrm>
            <a:off x="2424240" y="5373720"/>
            <a:ext cx="5616360" cy="45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Table S7: </a:t>
            </a:r>
            <a:r>
              <a:rPr b="0" lang="es-ES" sz="1100" spc="-1" strike="noStrike">
                <a:solidFill>
                  <a:srgbClr val="000000"/>
                </a:solidFill>
                <a:latin typeface="Calibri"/>
              </a:rPr>
              <a:t>Sequence of primers used by pyrosequencing in the validation assay of candidate genes obtained from 450k array</a:t>
            </a: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11T16:19:16Z</dcterms:created>
  <dc:creator>Angel Diaz Lagares</dc:creator>
  <dc:description/>
  <dc:language>en-US</dc:language>
  <cp:lastModifiedBy>JABELLA</cp:lastModifiedBy>
  <cp:lastPrinted>2018-04-16T13:28:07Z</cp:lastPrinted>
  <dcterms:modified xsi:type="dcterms:W3CDTF">2019-02-01T22:50:55Z</dcterms:modified>
  <cp:revision>178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Panorámica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8</vt:r8>
  </property>
</Properties>
</file>